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5361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24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8E2A8-711A-49FE-B280-656AD209DC95}" type="datetimeFigureOut">
              <a:rPr lang="de-DE" smtClean="0"/>
              <a:t>22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9E600-28C5-4727-8F82-BD1872FE01C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90268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8E2A8-711A-49FE-B280-656AD209DC95}" type="datetimeFigureOut">
              <a:rPr lang="de-DE" smtClean="0"/>
              <a:t>22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9E600-28C5-4727-8F82-BD1872FE01C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64043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8E2A8-711A-49FE-B280-656AD209DC95}" type="datetimeFigureOut">
              <a:rPr lang="de-DE" smtClean="0"/>
              <a:t>22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9E600-28C5-4727-8F82-BD1872FE01C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41019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8E2A8-711A-49FE-B280-656AD209DC95}" type="datetimeFigureOut">
              <a:rPr lang="de-DE" smtClean="0"/>
              <a:t>22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9E600-28C5-4727-8F82-BD1872FE01C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23795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8E2A8-711A-49FE-B280-656AD209DC95}" type="datetimeFigureOut">
              <a:rPr lang="de-DE" smtClean="0"/>
              <a:t>22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9E600-28C5-4727-8F82-BD1872FE01C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6414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8E2A8-711A-49FE-B280-656AD209DC95}" type="datetimeFigureOut">
              <a:rPr lang="de-DE" smtClean="0"/>
              <a:t>22.07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9E600-28C5-4727-8F82-BD1872FE01C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2517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8E2A8-711A-49FE-B280-656AD209DC95}" type="datetimeFigureOut">
              <a:rPr lang="de-DE" smtClean="0"/>
              <a:t>22.07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9E600-28C5-4727-8F82-BD1872FE01C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79170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8E2A8-711A-49FE-B280-656AD209DC95}" type="datetimeFigureOut">
              <a:rPr lang="de-DE" smtClean="0"/>
              <a:t>22.07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9E600-28C5-4727-8F82-BD1872FE01C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956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8E2A8-711A-49FE-B280-656AD209DC95}" type="datetimeFigureOut">
              <a:rPr lang="de-DE" smtClean="0"/>
              <a:t>22.07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9E600-28C5-4727-8F82-BD1872FE01C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14423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8E2A8-711A-49FE-B280-656AD209DC95}" type="datetimeFigureOut">
              <a:rPr lang="de-DE" smtClean="0"/>
              <a:t>22.07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9E600-28C5-4727-8F82-BD1872FE01C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39125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8E2A8-711A-49FE-B280-656AD209DC95}" type="datetimeFigureOut">
              <a:rPr lang="de-DE" smtClean="0"/>
              <a:t>22.07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9E600-28C5-4727-8F82-BD1872FE01C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39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28E2A8-711A-49FE-B280-656AD209DC95}" type="datetimeFigureOut">
              <a:rPr lang="de-DE" smtClean="0"/>
              <a:t>22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B9E600-28C5-4727-8F82-BD1872FE01C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45838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69B3EAE2-248D-CA6F-152F-36FC3D9D96E8}"/>
              </a:ext>
            </a:extLst>
          </p:cNvPr>
          <p:cNvSpPr txBox="1"/>
          <p:nvPr/>
        </p:nvSpPr>
        <p:spPr>
          <a:xfrm>
            <a:off x="5117599" y="9649099"/>
            <a:ext cx="17347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. Figure 1 Jenke et al.</a:t>
            </a:r>
          </a:p>
        </p:txBody>
      </p:sp>
      <p:pic>
        <p:nvPicPr>
          <p:cNvPr id="3" name="Grafik 2" descr="Ein Bild, das Text, Reihe, Schrift, Screenshot enthält.&#10;&#10;KI-generierte Inhalte können fehlerhaft sein.">
            <a:extLst>
              <a:ext uri="{FF2B5EF4-FFF2-40B4-BE49-F238E27FC236}">
                <a16:creationId xmlns:a16="http://schemas.microsoft.com/office/drawing/2014/main" id="{A0543A26-CED3-706F-CEB7-E8CFC1FA87C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483" y="788510"/>
            <a:ext cx="3378200" cy="3200400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ABDF0370-36F5-2BDC-ADC2-EED0CB9909F3}"/>
              </a:ext>
            </a:extLst>
          </p:cNvPr>
          <p:cNvSpPr txBox="1"/>
          <p:nvPr/>
        </p:nvSpPr>
        <p:spPr>
          <a:xfrm>
            <a:off x="522981" y="4399472"/>
            <a:ext cx="5110067" cy="774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Aptos"/>
                <a:cs typeface="Times New Roman" panose="02020603050405020304" pitchFamily="18" charset="0"/>
              </a:rPr>
              <a:t>Suppl. Figure 1 </a:t>
            </a:r>
            <a:r>
              <a:rPr lang="en-US" sz="1200" dirty="0">
                <a:effectLst/>
                <a:latin typeface="Arial" panose="020B0604020202020204" pitchFamily="34" charset="0"/>
                <a:ea typeface="Aptos"/>
                <a:cs typeface="Times New Roman" panose="02020603050405020304" pitchFamily="18" charset="0"/>
              </a:rPr>
              <a:t>Correlation of basal SLC7A11 expression vs. alterations in lipid peroxidation upon ERBB3 inhibition with TX1-85-1</a:t>
            </a:r>
            <a:endParaRPr lang="de-DE" sz="1200" dirty="0">
              <a:effectLst/>
              <a:latin typeface="Aptos"/>
              <a:ea typeface="Aptos"/>
              <a:cs typeface="Times New Roman" panose="02020603050405020304" pitchFamily="18" charset="0"/>
            </a:endParaRPr>
          </a:p>
          <a:p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794738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8</Words>
  <Application>Microsoft Office PowerPoint</Application>
  <PresentationFormat>A4-Papier (210 x 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enke, Robert</dc:creator>
  <cp:lastModifiedBy>Aigner, Achim</cp:lastModifiedBy>
  <cp:revision>31</cp:revision>
  <dcterms:created xsi:type="dcterms:W3CDTF">2024-08-28T20:38:42Z</dcterms:created>
  <dcterms:modified xsi:type="dcterms:W3CDTF">2025-07-22T06:28:16Z</dcterms:modified>
</cp:coreProperties>
</file>